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71" r:id="rId2"/>
    <p:sldId id="472" r:id="rId3"/>
    <p:sldId id="473" r:id="rId4"/>
    <p:sldId id="474" r:id="rId5"/>
    <p:sldId id="475" r:id="rId6"/>
    <p:sldId id="476" r:id="rId7"/>
    <p:sldId id="477" r:id="rId8"/>
    <p:sldId id="478" r:id="rId9"/>
    <p:sldId id="479" r:id="rId10"/>
    <p:sldId id="480" r:id="rId11"/>
    <p:sldId id="481" r:id="rId12"/>
    <p:sldId id="482" r:id="rId13"/>
    <p:sldId id="483" r:id="rId14"/>
    <p:sldId id="484" r:id="rId15"/>
    <p:sldId id="485" r:id="rId16"/>
    <p:sldId id="461" r:id="rId17"/>
    <p:sldId id="465" r:id="rId18"/>
    <p:sldId id="466" r:id="rId19"/>
    <p:sldId id="467" r:id="rId20"/>
    <p:sldId id="468" r:id="rId21"/>
    <p:sldId id="469" r:id="rId22"/>
    <p:sldId id="470" r:id="rId2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84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DF1255D-9784-3777-31E5-2E8C08D3CF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5E1586D0-E5E1-4EF7-3E6C-70E01D4B30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FA93395-ED1F-9638-4FAF-5E5B595CF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3081E-D007-42DF-BA74-A2B3FFDF0BDE}" type="datetimeFigureOut">
              <a:rPr lang="fr-FR" smtClean="0"/>
              <a:t>19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4723C4C-49D9-413B-C5E6-3E8183C30B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0F18FEF-96EB-9E6C-2E47-95F45D41B4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7B74C-1202-4273-B85C-726CBAE75A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9453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673BF14-C0B0-BB46-9C23-4DEB0B8513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116BCE2-0F5F-4CC5-FC5A-F8E06AE339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9A38251-E454-6E4C-6CAC-E88AD28520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3081E-D007-42DF-BA74-A2B3FFDF0BDE}" type="datetimeFigureOut">
              <a:rPr lang="fr-FR" smtClean="0"/>
              <a:t>19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9F3D677-B58A-26AA-579F-532129C0C4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7538657-45EE-8B4D-063E-FA127F4262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7B74C-1202-4273-B85C-726CBAE75A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8861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98B459B-3E33-B37D-1AD1-D633E35F56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3989FA4-F500-F012-A157-6BA5585E34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4003797-3105-7BAC-6D85-6CFA7E44E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3081E-D007-42DF-BA74-A2B3FFDF0BDE}" type="datetimeFigureOut">
              <a:rPr lang="fr-FR" smtClean="0"/>
              <a:t>19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E00EEAD-36EB-1B97-74C1-090E4F97E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AEC0927-6218-634E-3D48-0F6440BF05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7B74C-1202-4273-B85C-726CBAE75A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2489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668B696-027F-A4A2-B1F6-5AE70C2E09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574C469-5993-247C-1C98-F90FAFC034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1116E35-F7C0-A5E4-9FE6-DAD317C63D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3081E-D007-42DF-BA74-A2B3FFDF0BDE}" type="datetimeFigureOut">
              <a:rPr lang="fr-FR" smtClean="0"/>
              <a:t>19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3A2A214-96CE-EAA0-3F0B-90A2A17A0F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1F911D1-046A-F709-86AD-D26663260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7B74C-1202-4273-B85C-726CBAE75A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8403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7ED0C41-DA5D-640B-95DE-4DBD3BC64F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012D32A-76BD-D4EB-BC78-B2CAA66253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02BB3B3-B982-5021-7CB6-10E7280B19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3081E-D007-42DF-BA74-A2B3FFDF0BDE}" type="datetimeFigureOut">
              <a:rPr lang="fr-FR" smtClean="0"/>
              <a:t>19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BC9DBE6-CC68-9097-2DD8-4C54EADDB4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A06CF16-D576-FD06-DCDB-DAD9078791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7B74C-1202-4273-B85C-726CBAE75A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124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3E9DCFC-A595-0247-1E8D-AFD0A972D2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8AC5F9A-AF39-8265-3DC1-E9548255E2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77BFCAC-65F4-3049-16A2-BCA9289A91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19B7B2C-3783-D7B6-B873-FBE3C04E11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3081E-D007-42DF-BA74-A2B3FFDF0BDE}" type="datetimeFigureOut">
              <a:rPr lang="fr-FR" smtClean="0"/>
              <a:t>19/10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FEE2EB5-65DB-773E-917A-004DFBBE47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E7F4141-F1C8-6619-3E2F-D1B14350F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7B74C-1202-4273-B85C-726CBAE75A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4839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51E8D4F-9596-E61D-EFFF-9363FF8933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3B592A3-B480-98DE-5FAF-BD2C00C0A4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FF4C64E-11CF-DFEA-52A2-1A01D5772A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D273462-4328-7E78-AC79-A1D73625E4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209E49B-B7F8-9324-43BB-EB68C54492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A434C3F-44F0-A8F5-0176-FCE3FADEDB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3081E-D007-42DF-BA74-A2B3FFDF0BDE}" type="datetimeFigureOut">
              <a:rPr lang="fr-FR" smtClean="0"/>
              <a:t>19/10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D23C2CE-13B6-AEB1-EB40-6BA92037F2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462C39F-709D-B765-F7D4-F95A96D17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7B74C-1202-4273-B85C-726CBAE75A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6169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F740C11-1260-4152-A975-F8B7D38D00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2EA494C2-6E19-50F1-357F-5BA2CEDB3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3081E-D007-42DF-BA74-A2B3FFDF0BDE}" type="datetimeFigureOut">
              <a:rPr lang="fr-FR" smtClean="0"/>
              <a:t>19/10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706E8C0-9351-46D0-1B1B-58E79D0842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A0AB024E-227E-3A1A-7FBE-542D08A36B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7B74C-1202-4273-B85C-726CBAE75A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0855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DB10517A-AD9B-243A-0D6C-6C4C462AA5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3081E-D007-42DF-BA74-A2B3FFDF0BDE}" type="datetimeFigureOut">
              <a:rPr lang="fr-FR" smtClean="0"/>
              <a:t>19/10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BD5F9B5-8C77-6F6E-2E56-C4DE477B8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C9A5EEFA-DE8B-B731-D63A-AD6F31071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7B74C-1202-4273-B85C-726CBAE75A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0319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E63291B-FCB4-B8EF-EC5D-46D8153172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A217336-9435-98E9-7982-5AE011FC61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55F2C99-83DE-6F18-1572-2FF8753C9F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C7588E5-D7F7-8099-EB11-1E6BC9C9D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3081E-D007-42DF-BA74-A2B3FFDF0BDE}" type="datetimeFigureOut">
              <a:rPr lang="fr-FR" smtClean="0"/>
              <a:t>19/10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DD98025-FACE-1A76-3852-AA950FE3C9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D30EAD8-2FEA-A6C0-3064-23C2E5B05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7B74C-1202-4273-B85C-726CBAE75A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3008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964AD47-73BF-65A8-9AAE-01523BCBC6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2B731A5C-84AA-F53F-5D94-72644AAC9E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74D3FE8-EC02-E583-458A-516DB2FB03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A8DF388-AA49-040C-98DB-577A4AB707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3081E-D007-42DF-BA74-A2B3FFDF0BDE}" type="datetimeFigureOut">
              <a:rPr lang="fr-FR" smtClean="0"/>
              <a:t>19/10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F9A10F7-5509-9268-E25A-8E76A75F0E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BC921D7-F42B-3EDC-4A0F-0575FAB7F3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7B74C-1202-4273-B85C-726CBAE75A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0678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A9998B2A-D1DD-3546-BF48-9B6C45969D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A35E49F-BE2D-B75B-1459-A4A8BC42FA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B4E116E-00AC-E577-9022-F7F0D9ED81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B3081E-D007-42DF-BA74-A2B3FFDF0BDE}" type="datetimeFigureOut">
              <a:rPr lang="fr-FR" smtClean="0"/>
              <a:t>19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E9D5D6B-4F2B-78AF-4512-7CFAC28C8DF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D90C5FD-2739-D856-7A21-0A26F16272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97B74C-1202-4273-B85C-726CBAE75A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9648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737C1235-6A1E-5DE8-E173-32C1E29CF8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42478"/>
            <a:ext cx="12192000" cy="5084002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58981C5E-359D-AB35-2F0D-D8F0D9B7E508}"/>
              </a:ext>
            </a:extLst>
          </p:cNvPr>
          <p:cNvSpPr txBox="1"/>
          <p:nvPr/>
        </p:nvSpPr>
        <p:spPr>
          <a:xfrm>
            <a:off x="0" y="262890"/>
            <a:ext cx="2125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 err="1"/>
              <a:t>Facklamia</a:t>
            </a:r>
            <a:r>
              <a:rPr lang="fr-FR" b="1" i="1" dirty="0"/>
              <a:t> </a:t>
            </a:r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minis</a:t>
            </a:r>
          </a:p>
        </p:txBody>
      </p:sp>
    </p:spTree>
    <p:extLst>
      <p:ext uri="{BB962C8B-B14F-4D97-AF65-F5344CB8AC3E}">
        <p14:creationId xmlns:p14="http://schemas.microsoft.com/office/powerpoint/2010/main" val="23140758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14A356F0-690F-CEAE-0CCD-D217CE8C2BD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79773"/>
            <a:ext cx="12192000" cy="5574227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A7F694AD-F10E-1E1A-E312-DBF60F66F9EA}"/>
              </a:ext>
            </a:extLst>
          </p:cNvPr>
          <p:cNvSpPr txBox="1"/>
          <p:nvPr/>
        </p:nvSpPr>
        <p:spPr>
          <a:xfrm>
            <a:off x="0" y="262890"/>
            <a:ext cx="3554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ptococcus </a:t>
            </a:r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tellatus</a:t>
            </a:r>
            <a:endParaRPr lang="fr-FR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3448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94FE804A-5D08-4359-A677-93CA5B62FB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62241"/>
            <a:ext cx="12161537" cy="5595759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DC4360A1-CA7D-A807-5A75-64DD030EDE64}"/>
              </a:ext>
            </a:extLst>
          </p:cNvPr>
          <p:cNvSpPr txBox="1"/>
          <p:nvPr/>
        </p:nvSpPr>
        <p:spPr>
          <a:xfrm>
            <a:off x="0" y="262890"/>
            <a:ext cx="3554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terococcus </a:t>
            </a:r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ium</a:t>
            </a:r>
            <a:endParaRPr lang="fr-FR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953167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334F953F-BF1B-3B7D-9F55-95C9F9361C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00481"/>
            <a:ext cx="12192000" cy="5757519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B0FA48EE-F96C-061A-329A-9DB7C4FA1DD4}"/>
              </a:ext>
            </a:extLst>
          </p:cNvPr>
          <p:cNvSpPr txBox="1"/>
          <p:nvPr/>
        </p:nvSpPr>
        <p:spPr>
          <a:xfrm>
            <a:off x="0" y="262890"/>
            <a:ext cx="3554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terocloster</a:t>
            </a:r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lteae</a:t>
            </a:r>
            <a:endParaRPr lang="fr-FR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119512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BCE13021-773A-8DD5-E1F3-1DBC306339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58573"/>
            <a:ext cx="12033868" cy="5385077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CB6A900F-0E65-41E7-727F-A7735C323BDD}"/>
              </a:ext>
            </a:extLst>
          </p:cNvPr>
          <p:cNvSpPr txBox="1"/>
          <p:nvPr/>
        </p:nvSpPr>
        <p:spPr>
          <a:xfrm>
            <a:off x="0" y="262890"/>
            <a:ext cx="3554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tibacterium</a:t>
            </a:r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idum</a:t>
            </a:r>
            <a:endParaRPr lang="fr-FR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248542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B21092E1-72EC-A862-CA56-DCB13A7F19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07135"/>
            <a:ext cx="12192000" cy="540385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0FC76004-191D-D820-719D-45DE31E2ED76}"/>
              </a:ext>
            </a:extLst>
          </p:cNvPr>
          <p:cNvSpPr txBox="1"/>
          <p:nvPr/>
        </p:nvSpPr>
        <p:spPr>
          <a:xfrm>
            <a:off x="0" y="262890"/>
            <a:ext cx="3554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oides</a:t>
            </a:r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taiotaomicron</a:t>
            </a:r>
            <a:endParaRPr lang="fr-FR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189314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Police, nombre&#10;&#10;Description générée automatiquement">
            <a:extLst>
              <a:ext uri="{FF2B5EF4-FFF2-40B4-BE49-F238E27FC236}">
                <a16:creationId xmlns:a16="http://schemas.microsoft.com/office/drawing/2014/main" id="{95CC7FC4-701F-1E16-C6A0-61E6CDBF02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40" y="1108417"/>
            <a:ext cx="12100560" cy="5617641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26A3E1E0-6DD6-050B-47D5-55B9EFEB4FE0}"/>
              </a:ext>
            </a:extLst>
          </p:cNvPr>
          <p:cNvSpPr txBox="1"/>
          <p:nvPr/>
        </p:nvSpPr>
        <p:spPr>
          <a:xfrm>
            <a:off x="0" y="262890"/>
            <a:ext cx="3554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istipes</a:t>
            </a:r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munis</a:t>
            </a:r>
            <a:endParaRPr lang="fr-FR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89217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9FAD8D8F-4ED9-4C76-CD9D-797140A3C73C}"/>
              </a:ext>
            </a:extLst>
          </p:cNvPr>
          <p:cNvSpPr txBox="1"/>
          <p:nvPr/>
        </p:nvSpPr>
        <p:spPr>
          <a:xfrm>
            <a:off x="2868930" y="0"/>
            <a:ext cx="5440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Enterocloster</a:t>
            </a:r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b="1" dirty="0" err="1">
                <a:latin typeface="Arial" panose="020B0604020202020204" pitchFamily="34" charset="0"/>
                <a:cs typeface="Arial" panose="020B0604020202020204" pitchFamily="34" charset="0"/>
              </a:rPr>
              <a:t>genus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 3" descr="Une image contenant texte, capture d’écran, Police, nombre&#10;&#10;Description générée automatiquement">
            <a:extLst>
              <a:ext uri="{FF2B5EF4-FFF2-40B4-BE49-F238E27FC236}">
                <a16:creationId xmlns:a16="http://schemas.microsoft.com/office/drawing/2014/main" id="{B58E44D8-4AF1-5C07-6E96-8EEAD45FEB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310" y="1120002"/>
            <a:ext cx="11627448" cy="5372376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28D72FB6-E6A6-6244-4B3C-D7CA45C652EB}"/>
              </a:ext>
            </a:extLst>
          </p:cNvPr>
          <p:cNvSpPr txBox="1"/>
          <p:nvPr/>
        </p:nvSpPr>
        <p:spPr>
          <a:xfrm>
            <a:off x="-41910" y="560001"/>
            <a:ext cx="5440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Enterocloster</a:t>
            </a:r>
            <a:r>
              <a:rPr lang="fr-FR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lavalensis</a:t>
            </a:r>
            <a:endParaRPr lang="fr-FR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69919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D193E85F-E187-E93E-8FEF-574352F291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7074"/>
            <a:ext cx="12086887" cy="5598974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1930539B-FD40-B539-A997-D786D3DF2191}"/>
              </a:ext>
            </a:extLst>
          </p:cNvPr>
          <p:cNvSpPr txBox="1"/>
          <p:nvPr/>
        </p:nvSpPr>
        <p:spPr>
          <a:xfrm>
            <a:off x="0" y="560001"/>
            <a:ext cx="5440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Enterocloster</a:t>
            </a:r>
            <a:r>
              <a:rPr lang="fr-FR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clostridioformis</a:t>
            </a:r>
            <a:endParaRPr lang="fr-FR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804230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7932279C-CA29-D974-3506-82EAF1152C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59631"/>
            <a:ext cx="12192000" cy="5621978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5E2B78E3-9D4F-2CFE-FF54-5F31470944B5}"/>
              </a:ext>
            </a:extLst>
          </p:cNvPr>
          <p:cNvSpPr txBox="1"/>
          <p:nvPr/>
        </p:nvSpPr>
        <p:spPr>
          <a:xfrm>
            <a:off x="0" y="560001"/>
            <a:ext cx="5440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Enterocloster</a:t>
            </a:r>
            <a:r>
              <a:rPr lang="fr-FR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citroniae</a:t>
            </a:r>
            <a:endParaRPr lang="fr-FR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966572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98A40E6E-B7DC-A6FA-5538-6A04DA9AA3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13823"/>
            <a:ext cx="12192000" cy="5744178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55E99CCD-BDF0-6B5E-B353-ACF76F15CCED}"/>
              </a:ext>
            </a:extLst>
          </p:cNvPr>
          <p:cNvSpPr txBox="1"/>
          <p:nvPr/>
        </p:nvSpPr>
        <p:spPr>
          <a:xfrm>
            <a:off x="0" y="514281"/>
            <a:ext cx="5440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Enterocloster</a:t>
            </a:r>
            <a:r>
              <a:rPr lang="fr-FR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bolteae</a:t>
            </a:r>
            <a:endParaRPr lang="fr-FR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01682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Police, nombre&#10;&#10;Description générée automatiquement">
            <a:extLst>
              <a:ext uri="{FF2B5EF4-FFF2-40B4-BE49-F238E27FC236}">
                <a16:creationId xmlns:a16="http://schemas.microsoft.com/office/drawing/2014/main" id="{45BFFA34-65B1-FBB6-C57B-24FEB7F21E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1257300"/>
            <a:ext cx="12045881" cy="5513204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E6F6CACB-DD5A-7668-576D-86517A1F9E73}"/>
              </a:ext>
            </a:extLst>
          </p:cNvPr>
          <p:cNvSpPr txBox="1"/>
          <p:nvPr/>
        </p:nvSpPr>
        <p:spPr>
          <a:xfrm>
            <a:off x="0" y="262890"/>
            <a:ext cx="2125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 err="1"/>
              <a:t>Finegoldia</a:t>
            </a:r>
            <a:r>
              <a:rPr lang="fr-FR" b="1" i="1" dirty="0"/>
              <a:t> </a:t>
            </a:r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gna</a:t>
            </a:r>
          </a:p>
        </p:txBody>
      </p:sp>
    </p:spTree>
    <p:extLst>
      <p:ext uri="{BB962C8B-B14F-4D97-AF65-F5344CB8AC3E}">
        <p14:creationId xmlns:p14="http://schemas.microsoft.com/office/powerpoint/2010/main" val="220914715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Police, nombre&#10;&#10;Description générée automatiquement">
            <a:extLst>
              <a:ext uri="{FF2B5EF4-FFF2-40B4-BE49-F238E27FC236}">
                <a16:creationId xmlns:a16="http://schemas.microsoft.com/office/drawing/2014/main" id="{82606BDB-DEBA-7BA1-407E-97A6E4DABA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02970"/>
            <a:ext cx="12355486" cy="595503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E21D6923-4288-23C9-DC49-099E678DB2F4}"/>
              </a:ext>
            </a:extLst>
          </p:cNvPr>
          <p:cNvSpPr txBox="1"/>
          <p:nvPr/>
        </p:nvSpPr>
        <p:spPr>
          <a:xfrm>
            <a:off x="0" y="514281"/>
            <a:ext cx="5440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Enterocloster</a:t>
            </a:r>
            <a:r>
              <a:rPr lang="fr-FR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aspargiformis</a:t>
            </a:r>
            <a:endParaRPr lang="fr-FR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864796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Police, nombre&#10;&#10;Description générée automatiquement">
            <a:extLst>
              <a:ext uri="{FF2B5EF4-FFF2-40B4-BE49-F238E27FC236}">
                <a16:creationId xmlns:a16="http://schemas.microsoft.com/office/drawing/2014/main" id="{D494C907-C54C-BEFC-A555-800D676831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210322"/>
            <a:ext cx="12241531" cy="5529069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A9791236-DD36-BD76-8196-8C9530654D82}"/>
              </a:ext>
            </a:extLst>
          </p:cNvPr>
          <p:cNvSpPr txBox="1"/>
          <p:nvPr/>
        </p:nvSpPr>
        <p:spPr>
          <a:xfrm>
            <a:off x="0" y="468561"/>
            <a:ext cx="5440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Enterocloster</a:t>
            </a:r>
            <a:r>
              <a:rPr lang="fr-FR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aldenensis</a:t>
            </a:r>
            <a:endParaRPr lang="fr-FR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268744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C5C3487B-3FE9-F691-4BD8-261A1F507F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49279" y="1440180"/>
            <a:ext cx="12241279" cy="533921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7CF045DA-A7E2-93D0-04B6-7F2195D278FD}"/>
              </a:ext>
            </a:extLst>
          </p:cNvPr>
          <p:cNvSpPr txBox="1"/>
          <p:nvPr/>
        </p:nvSpPr>
        <p:spPr>
          <a:xfrm>
            <a:off x="0" y="468561"/>
            <a:ext cx="5440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Enterocloster</a:t>
            </a:r>
            <a:r>
              <a:rPr lang="fr-FR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b="1" i="1" dirty="0" err="1">
                <a:latin typeface="Arial" panose="020B0604020202020204" pitchFamily="34" charset="0"/>
                <a:cs typeface="Arial" panose="020B0604020202020204" pitchFamily="34" charset="0"/>
              </a:rPr>
              <a:t>alcoholeydrogenati</a:t>
            </a:r>
            <a:endParaRPr lang="fr-FR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26993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14A68E2D-2514-06E2-B17B-C99AE5186A8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23880"/>
            <a:ext cx="12192000" cy="5743452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15F5058E-6647-F1F6-0BFD-898076F32F0E}"/>
              </a:ext>
            </a:extLst>
          </p:cNvPr>
          <p:cNvSpPr txBox="1"/>
          <p:nvPr/>
        </p:nvSpPr>
        <p:spPr>
          <a:xfrm>
            <a:off x="0" y="262890"/>
            <a:ext cx="2868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ldemanella</a:t>
            </a:r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formis</a:t>
            </a:r>
            <a:endParaRPr lang="fr-FR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08805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3A64CF5C-9EEB-A8A5-58BC-7AA26EB338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42937"/>
            <a:ext cx="12192000" cy="5726959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326D8211-726D-0D57-66A0-8B2725E69468}"/>
              </a:ext>
            </a:extLst>
          </p:cNvPr>
          <p:cNvSpPr txBox="1"/>
          <p:nvPr/>
        </p:nvSpPr>
        <p:spPr>
          <a:xfrm>
            <a:off x="0" y="262890"/>
            <a:ext cx="2868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cticaseibacillus</a:t>
            </a:r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sei</a:t>
            </a:r>
          </a:p>
        </p:txBody>
      </p:sp>
    </p:spTree>
    <p:extLst>
      <p:ext uri="{BB962C8B-B14F-4D97-AF65-F5344CB8AC3E}">
        <p14:creationId xmlns:p14="http://schemas.microsoft.com/office/powerpoint/2010/main" val="19255098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00937C4E-8C2A-DC76-8453-9A43D3F5AE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05890"/>
            <a:ext cx="12078520" cy="545211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410470FD-7666-39B5-63AB-96FB6ED99C84}"/>
              </a:ext>
            </a:extLst>
          </p:cNvPr>
          <p:cNvSpPr txBox="1"/>
          <p:nvPr/>
        </p:nvSpPr>
        <p:spPr>
          <a:xfrm>
            <a:off x="0" y="262890"/>
            <a:ext cx="3554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ntilactobacillus</a:t>
            </a:r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buchneri</a:t>
            </a:r>
            <a:endParaRPr lang="fr-FR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70431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E3B9B71A-81EF-8597-2CCE-99BCA5E6B8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89422"/>
            <a:ext cx="12192000" cy="5767754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7DCC5B3D-FE08-29FB-0ABF-752376BD0602}"/>
              </a:ext>
            </a:extLst>
          </p:cNvPr>
          <p:cNvSpPr txBox="1"/>
          <p:nvPr/>
        </p:nvSpPr>
        <p:spPr>
          <a:xfrm>
            <a:off x="0" y="262890"/>
            <a:ext cx="3554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mosilactobacillus</a:t>
            </a:r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mentum</a:t>
            </a:r>
            <a:endParaRPr lang="fr-FR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28819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logiciel&#10;&#10;Description générée automatiquement">
            <a:extLst>
              <a:ext uri="{FF2B5EF4-FFF2-40B4-BE49-F238E27FC236}">
                <a16:creationId xmlns:a16="http://schemas.microsoft.com/office/drawing/2014/main" id="{82AEE6EF-7DDE-BC4B-1471-8B073D1102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08710"/>
            <a:ext cx="11996063" cy="56256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66743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385FEC8D-8E5C-CD92-83BD-8356025D95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44" y="1213468"/>
            <a:ext cx="12001165" cy="5644532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02315174-DB50-CDF5-EAA3-3946FA2E0C80}"/>
              </a:ext>
            </a:extLst>
          </p:cNvPr>
          <p:cNvSpPr txBox="1"/>
          <p:nvPr/>
        </p:nvSpPr>
        <p:spPr>
          <a:xfrm>
            <a:off x="0" y="262890"/>
            <a:ext cx="3554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ptoniphilus</a:t>
            </a:r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enoeneniae</a:t>
            </a:r>
            <a:endParaRPr lang="fr-FR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902175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texte, capture d’écran, nombre, Police&#10;&#10;Description générée automatiquement">
            <a:extLst>
              <a:ext uri="{FF2B5EF4-FFF2-40B4-BE49-F238E27FC236}">
                <a16:creationId xmlns:a16="http://schemas.microsoft.com/office/drawing/2014/main" id="{99569850-079E-9E19-3800-A71F04D1A0A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13675"/>
            <a:ext cx="11710002" cy="544223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5D5AC90D-83E1-5A5C-D95F-EF6A0CB7D5D7}"/>
              </a:ext>
            </a:extLst>
          </p:cNvPr>
          <p:cNvSpPr txBox="1"/>
          <p:nvPr/>
        </p:nvSpPr>
        <p:spPr>
          <a:xfrm>
            <a:off x="0" y="262890"/>
            <a:ext cx="3554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scolarctobacterium</a:t>
            </a:r>
            <a:r>
              <a:rPr lang="fr-F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aecium</a:t>
            </a:r>
          </a:p>
        </p:txBody>
      </p:sp>
    </p:spTree>
    <p:extLst>
      <p:ext uri="{BB962C8B-B14F-4D97-AF65-F5344CB8AC3E}">
        <p14:creationId xmlns:p14="http://schemas.microsoft.com/office/powerpoint/2010/main" val="353180821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4</Words>
  <Application>Microsoft Office PowerPoint</Application>
  <PresentationFormat>Grand écran</PresentationFormat>
  <Paragraphs>22</Paragraphs>
  <Slides>2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2</vt:i4>
      </vt:variant>
    </vt:vector>
  </HeadingPairs>
  <TitlesOfParts>
    <vt:vector size="2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abacar Mbaye</dc:creator>
  <cp:lastModifiedBy>Babacar Mbaye</cp:lastModifiedBy>
  <cp:revision>1</cp:revision>
  <dcterms:created xsi:type="dcterms:W3CDTF">2023-10-18T22:09:37Z</dcterms:created>
  <dcterms:modified xsi:type="dcterms:W3CDTF">2023-10-18T22:16:40Z</dcterms:modified>
</cp:coreProperties>
</file>